
<file path=[Content_Types].xml><?xml version="1.0" encoding="utf-8"?>
<Types xmlns="http://schemas.openxmlformats.org/package/2006/content-types">
  <Default Extension="fntdata" ContentType="application/x-fontdata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3"/>
  </p:notesMasterIdLst>
  <p:sldIdLst>
    <p:sldId id="357" r:id="rId2"/>
  </p:sldIdLst>
  <p:sldSz cx="7559675" cy="10691813"/>
  <p:notesSz cx="6797675" cy="9926638"/>
  <p:embeddedFontLst>
    <p:embeddedFont>
      <p:font typeface="Arial Narrow" panose="020B0606020202030204" pitchFamily="34" charset="0"/>
      <p:regular r:id="rId4"/>
      <p:bold r:id="rId5"/>
      <p:italic r:id="rId6"/>
      <p:boldItalic r:id="rId7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521415D9-36F7-43E2-AB2F-B90AF26B5E84}">
      <p14:sectionLst xmlns:p14="http://schemas.microsoft.com/office/powerpoint/2010/main">
        <p14:section name="Sección predeterminada" id="{D5E2DED0-5F50-4222-9EAF-844EBF4BC019}">
          <p14:sldIdLst>
            <p14:sldId id="357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415" userDrawn="1">
          <p15:clr>
            <a:srgbClr val="A4A3A4"/>
          </p15:clr>
        </p15:guide>
        <p15:guide id="2" pos="816" userDrawn="1">
          <p15:clr>
            <a:srgbClr val="A4A3A4"/>
          </p15:clr>
        </p15:guide>
      </p15:sldGuideLst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23" roundtripDataSignature="AMtx7mhk9o0VoqnGx53rixO4Hlj7SN98/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500FF"/>
    <a:srgbClr val="00FFF4"/>
    <a:srgbClr val="FFF700"/>
    <a:srgbClr val="FF0000"/>
    <a:srgbClr val="00FFCA"/>
    <a:srgbClr val="FF8000"/>
    <a:srgbClr val="002AFF"/>
    <a:srgbClr val="F1D9C0"/>
    <a:srgbClr val="FFA800"/>
    <a:srgbClr val="007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Estilo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820" autoAdjust="0"/>
    <p:restoredTop sz="88645" autoAdjust="0"/>
  </p:normalViewPr>
  <p:slideViewPr>
    <p:cSldViewPr snapToGrid="0">
      <p:cViewPr>
        <p:scale>
          <a:sx n="50" d="100"/>
          <a:sy n="50" d="100"/>
        </p:scale>
        <p:origin x="2904" y="-34"/>
      </p:cViewPr>
      <p:guideLst>
        <p:guide orient="horz" pos="2415"/>
        <p:guide pos="81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26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24" Type="http://schemas.openxmlformats.org/officeDocument/2006/relationships/presProps" Target="presProps.xml"/><Relationship Id="rId5" Type="http://schemas.openxmlformats.org/officeDocument/2006/relationships/font" Target="fonts/font2.fntdata"/><Relationship Id="rId23" Type="http://customschemas.google.com/relationships/presentationmetadata" Target="metadata"/><Relationship Id="rId4" Type="http://schemas.openxmlformats.org/officeDocument/2006/relationships/font" Target="fonts/font1.fntdata"/><Relationship Id="rId27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2082800" y="744538"/>
            <a:ext cx="2633663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8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82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8009" indent="0" algn="ctr">
              <a:buNone/>
              <a:defRPr sz="1653"/>
            </a:lvl2pPr>
            <a:lvl3pPr marL="756017" indent="0" algn="ctr">
              <a:buNone/>
              <a:defRPr sz="1488"/>
            </a:lvl3pPr>
            <a:lvl4pPr marL="1134026" indent="0" algn="ctr">
              <a:buNone/>
              <a:defRPr sz="1323"/>
            </a:lvl4pPr>
            <a:lvl5pPr marL="1512035" indent="0" algn="ctr">
              <a:buNone/>
              <a:defRPr sz="1323"/>
            </a:lvl5pPr>
            <a:lvl6pPr marL="1890043" indent="0" algn="ctr">
              <a:buNone/>
              <a:defRPr sz="1323"/>
            </a:lvl6pPr>
            <a:lvl7pPr marL="2268052" indent="0" algn="ctr">
              <a:buNone/>
              <a:defRPr sz="1323"/>
            </a:lvl7pPr>
            <a:lvl8pPr marL="2646061" indent="0" algn="ctr">
              <a:buNone/>
              <a:defRPr sz="1323"/>
            </a:lvl8pPr>
            <a:lvl9pPr marL="3024069" indent="0" algn="ctr">
              <a:buNone/>
              <a:defRPr sz="1323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7052D-A19D-4146-9DC8-BE12F1129ED6}" type="datetimeFigureOut">
              <a:rPr lang="es-ES" smtClean="0"/>
              <a:t>20/04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B561B0-4526-4226-81D9-5F61190FD33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890717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8"/>
          <p:cNvSpPr txBox="1"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37"/>
              <a:buFont typeface="Calibri"/>
              <a:buNone/>
              <a:defRPr sz="363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8"/>
          <p:cNvSpPr txBox="1">
            <a:spLocks noGrp="1"/>
          </p:cNvSpPr>
          <p:nvPr>
            <p:ph type="body" idx="1"/>
          </p:nvPr>
        </p:nvSpPr>
        <p:spPr>
          <a:xfrm>
            <a:off x="519728" y="2846204"/>
            <a:ext cx="6520220" cy="678385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75602" algn="l" rtl="0">
              <a:lnSpc>
                <a:spcPct val="90000"/>
              </a:lnSpc>
              <a:spcBef>
                <a:spcPts val="827"/>
              </a:spcBef>
              <a:spcAft>
                <a:spcPts val="0"/>
              </a:spcAft>
              <a:buClr>
                <a:schemeClr val="dk1"/>
              </a:buClr>
              <a:buSzPts val="2315"/>
              <a:buFont typeface="Arial"/>
              <a:buChar char="•"/>
              <a:defRPr sz="231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54583" algn="l" rtl="0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984"/>
              <a:buFont typeface="Arial"/>
              <a:buChar char="•"/>
              <a:defRPr sz="198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33565" algn="l" rtl="0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653"/>
              <a:buFont typeface="Arial"/>
              <a:buChar char="•"/>
              <a:defRPr sz="165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23088" algn="l" rtl="0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488"/>
              <a:buFont typeface="Arial"/>
              <a:buChar char="•"/>
              <a:defRPr sz="148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23088" algn="l" rtl="0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488"/>
              <a:buFont typeface="Arial"/>
              <a:buChar char="•"/>
              <a:defRPr sz="148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23088" algn="l" rtl="0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488"/>
              <a:buFont typeface="Arial"/>
              <a:buChar char="•"/>
              <a:defRPr sz="148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23088" algn="l" rtl="0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488"/>
              <a:buFont typeface="Arial"/>
              <a:buChar char="•"/>
              <a:defRPr sz="148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23088" algn="l" rtl="0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488"/>
              <a:buFont typeface="Arial"/>
              <a:buChar char="•"/>
              <a:defRPr sz="148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23088" algn="l" rtl="0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488"/>
              <a:buFont typeface="Arial"/>
              <a:buChar char="•"/>
              <a:defRPr sz="148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8"/>
          <p:cNvSpPr txBox="1">
            <a:spLocks noGrp="1"/>
          </p:cNvSpPr>
          <p:nvPr>
            <p:ph type="dt" idx="10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9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8"/>
          <p:cNvSpPr txBox="1">
            <a:spLocks noGrp="1"/>
          </p:cNvSpPr>
          <p:nvPr>
            <p:ph type="ftr" idx="11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9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8"/>
          <p:cNvSpPr txBox="1">
            <a:spLocks noGrp="1"/>
          </p:cNvSpPr>
          <p:nvPr>
            <p:ph type="sldNum" idx="12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92"/>
              <a:buFont typeface="Arial"/>
              <a:buNone/>
              <a:defRPr sz="99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92"/>
              <a:buFont typeface="Arial"/>
              <a:buNone/>
              <a:defRPr sz="99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92"/>
              <a:buFont typeface="Arial"/>
              <a:buNone/>
              <a:defRPr sz="99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92"/>
              <a:buFont typeface="Arial"/>
              <a:buNone/>
              <a:defRPr sz="99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92"/>
              <a:buFont typeface="Arial"/>
              <a:buNone/>
              <a:defRPr sz="99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92"/>
              <a:buFont typeface="Arial"/>
              <a:buNone/>
              <a:defRPr sz="99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92"/>
              <a:buFont typeface="Arial"/>
              <a:buNone/>
              <a:defRPr sz="99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92"/>
              <a:buFont typeface="Arial"/>
              <a:buNone/>
              <a:defRPr sz="99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92"/>
              <a:buFont typeface="Arial"/>
              <a:buNone/>
              <a:defRPr sz="99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61" r:id="rId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oogle Shape;84;p1">
            <a:extLst>
              <a:ext uri="{FF2B5EF4-FFF2-40B4-BE49-F238E27FC236}">
                <a16:creationId xmlns:a16="http://schemas.microsoft.com/office/drawing/2014/main" id="{09AE1801-4AD3-9CAB-2B5D-979B4D6335F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796088415"/>
              </p:ext>
            </p:extLst>
          </p:nvPr>
        </p:nvGraphicFramePr>
        <p:xfrm>
          <a:off x="129807" y="7084097"/>
          <a:ext cx="7308000" cy="2650725"/>
        </p:xfrm>
        <a:graphic>
          <a:graphicData uri="http://schemas.openxmlformats.org/drawingml/2006/table">
            <a:tbl>
              <a:tblPr>
                <a:noFill/>
              </a:tblPr>
              <a:tblGrid>
                <a:gridCol w="792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04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4320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</a:tblGrid>
              <a:tr h="290325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 dirty="0" err="1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Phylum</a:t>
                      </a:r>
                      <a:endParaRPr dirty="0"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Genetic background or reference</a:t>
                      </a:r>
                      <a:endParaRPr sz="1000" b="1" i="0" u="none" strike="noStrike" cap="none">
                        <a:solidFill>
                          <a:srgbClr val="000000"/>
                        </a:solidFill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5925" marR="5925" marT="59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1" u="none" strike="noStrike" cap="none" dirty="0" err="1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purT</a:t>
                      </a:r>
                      <a:endParaRPr dirty="0"/>
                    </a:p>
                  </a:txBody>
                  <a:tcPr marL="5925" marR="5925" marT="59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1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purF</a:t>
                      </a:r>
                      <a:endParaRPr sz="1000" b="1" i="1" u="none" strike="noStrike" cap="none">
                        <a:solidFill>
                          <a:srgbClr val="000000"/>
                        </a:solidFill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5925" marR="5925" marT="5925" marB="0" anchor="ctr">
                    <a:lnL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1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prs</a:t>
                      </a:r>
                      <a:endParaRPr sz="1000" b="1" i="1" u="none" strike="noStrike" cap="none">
                        <a:solidFill>
                          <a:srgbClr val="000000"/>
                        </a:solidFill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5925" marR="5925" marT="5925" marB="0" anchor="ctr">
                    <a:lnL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1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hprT</a:t>
                      </a:r>
                      <a:endParaRPr sz="1000" b="1" i="1" u="none" strike="noStrike" cap="none">
                        <a:solidFill>
                          <a:srgbClr val="000000"/>
                        </a:solidFill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5925" marR="5925" marT="5925" marB="0" anchor="ctr">
                    <a:lnL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1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guaA</a:t>
                      </a:r>
                      <a:endParaRPr sz="1000" b="1" i="1" u="none" strike="noStrike" cap="none">
                        <a:solidFill>
                          <a:srgbClr val="000000"/>
                        </a:solidFill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5925" marR="5925" marT="5925" marB="0" anchor="ctr">
                    <a:lnL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1" u="none" strike="noStrike" cap="none" dirty="0" err="1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guaB</a:t>
                      </a:r>
                      <a:r>
                        <a:rPr lang="es-ES" sz="1000" b="1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(</a:t>
                      </a:r>
                      <a:r>
                        <a:rPr lang="es-ES" sz="1000" b="1" i="1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3</a:t>
                      </a:r>
                      <a:r>
                        <a:rPr lang="es-ES" sz="1000" b="1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)</a:t>
                      </a:r>
                      <a:endParaRPr i="0" dirty="0"/>
                    </a:p>
                  </a:txBody>
                  <a:tcPr marL="5925" marR="5925" marT="5925" marB="0" anchor="ctr">
                    <a:lnL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1" u="none" strike="noStrike" cap="none" dirty="0" err="1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gmK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1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codY</a:t>
                      </a:r>
                      <a:endParaRPr/>
                    </a:p>
                  </a:txBody>
                  <a:tcPr marL="5925" marR="5925" marT="5925" marB="0" anchor="ctr">
                    <a:lnL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1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_0187</a:t>
                      </a:r>
                      <a:r>
                        <a:rPr lang="es-ES" sz="1000" b="1" i="1" u="none" strike="noStrike" cap="none" baseline="30000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h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1" u="none" strike="noStrike" cap="none" dirty="0" err="1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rpoB</a:t>
                      </a:r>
                      <a:endParaRPr sz="1000" b="1" i="1" u="none" strike="noStrike" cap="none" dirty="0">
                        <a:solidFill>
                          <a:srgbClr val="000000"/>
                        </a:solidFill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5925" marR="5925" marT="5925" marB="0" anchor="ctr">
                    <a:lnL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1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rpoC</a:t>
                      </a:r>
                      <a:endParaRPr sz="1000" b="1" i="1" u="none" strike="noStrike" cap="none">
                        <a:solidFill>
                          <a:srgbClr val="000000"/>
                        </a:solidFill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5925" marR="5925" marT="5925" marB="0" anchor="ctr">
                    <a:lnL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1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rpoD</a:t>
                      </a:r>
                      <a:endParaRPr/>
                    </a:p>
                  </a:txBody>
                  <a:tcPr marL="5925" marR="5925" marT="5925" marB="0" anchor="ctr">
                    <a:lnL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1" u="none" strike="noStrike" cap="none" dirty="0" err="1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rpoN</a:t>
                      </a:r>
                      <a:r>
                        <a:rPr lang="es-ES" sz="1000" b="1" i="1" u="none" strike="noStrike" cap="none" baseline="30000" dirty="0" err="1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h</a:t>
                      </a:r>
                      <a:endParaRPr baseline="30000" dirty="0"/>
                    </a:p>
                  </a:txBody>
                  <a:tcPr marL="5925" marR="5925" marT="5925" marB="0" anchor="ctr">
                    <a:lnL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1" u="none" strike="noStrike" cap="none" dirty="0" err="1">
                          <a:solidFill>
                            <a:srgbClr val="000000"/>
                          </a:solidFill>
                          <a:latin typeface="Arial Narrow"/>
                          <a:sym typeface="Arial Narrow"/>
                        </a:rPr>
                        <a:t>rpsB</a:t>
                      </a:r>
                      <a:endParaRPr i="1" dirty="0"/>
                    </a:p>
                  </a:txBody>
                  <a:tcPr marL="5925" marR="5925" marT="5925" marB="0" anchor="ctr">
                    <a:lnL w="9525" cap="flat" cmpd="sng" algn="ctr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0000">
                <a:tc rowSpan="3"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548235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 dirty="0" err="1">
                          <a:solidFill>
                            <a:srgbClr val="548235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Cyanobacteria</a:t>
                      </a:r>
                      <a:endParaRPr dirty="0"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WT1</a:t>
                      </a:r>
                      <a:endParaRPr dirty="0"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 dirty="0"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13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WT2</a:t>
                      </a:r>
                      <a:endParaRPr dirty="0"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1</a:t>
                      </a:r>
                      <a:endParaRPr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4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4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1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5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2EFD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 dirty="0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Total</a:t>
                      </a:r>
                      <a:endParaRPr dirty="0"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1</a:t>
                      </a:r>
                      <a:endParaRPr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 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 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 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4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 dirty="0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4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 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 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1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 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 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 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 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 dirty="0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18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54823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0000">
                <a:tc rowSpan="3"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1F4E78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 dirty="0" err="1">
                          <a:solidFill>
                            <a:srgbClr val="1F4E78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Firmicutes</a:t>
                      </a:r>
                      <a:endParaRPr dirty="0"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 err="1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Kriel</a:t>
                      </a: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, 2012</a:t>
                      </a:r>
                      <a:endParaRPr dirty="0"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8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18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2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10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Osaka, 2020</a:t>
                      </a:r>
                      <a:endParaRPr dirty="0"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1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2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3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 gridSpan="4"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53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2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2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DEB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Total</a:t>
                      </a:r>
                      <a:endParaRPr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1F4E7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 </a:t>
                      </a:r>
                      <a:endParaRPr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1F4E7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1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1F4E7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2</a:t>
                      </a:r>
                      <a:endParaRPr sz="1000" b="1" i="0" u="none" strike="noStrike" cap="none">
                        <a:solidFill>
                          <a:srgbClr val="FFFFFF"/>
                        </a:solidFill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1F4E7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3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1F4E78"/>
                    </a:solidFill>
                  </a:tcPr>
                </a:tc>
                <a:tc gridSpan="4"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91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1F4E78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 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1F4E7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2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1F4E7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 dirty="0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2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1F4E7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 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1F4E7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 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1F4E7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 dirty="0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 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1F4E7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0000">
                <a:tc rowSpan="7"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806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 dirty="0">
                          <a:solidFill>
                            <a:srgbClr val="806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Proteobacteria</a:t>
                      </a:r>
                      <a:endParaRPr dirty="0"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Hernández and </a:t>
                      </a:r>
                      <a:r>
                        <a:rPr lang="es-ES" sz="1000" b="0" i="0" u="none" strike="noStrike" cap="none" dirty="0" err="1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Cashel</a:t>
                      </a: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 1995</a:t>
                      </a:r>
                      <a:endParaRPr dirty="0"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6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Laurie et al, 2003</a:t>
                      </a:r>
                      <a:endParaRPr dirty="0"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65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2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1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Murphy and </a:t>
                      </a:r>
                      <a:r>
                        <a:rPr lang="es-ES" sz="1000" b="0" i="0" u="none" strike="noStrike" cap="none" dirty="0" err="1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Cashel</a:t>
                      </a: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, 2003</a:t>
                      </a:r>
                      <a:endParaRPr dirty="0"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85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94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3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 err="1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Szalewska-Palasz</a:t>
                      </a: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,  2007</a:t>
                      </a:r>
                      <a:endParaRPr dirty="0"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19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12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Perrier et al, 2025</a:t>
                      </a:r>
                      <a:endParaRPr dirty="0"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31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17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Wells and Long, 2003</a:t>
                      </a:r>
                      <a:endParaRPr dirty="0"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2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2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0" i="0" u="none" strike="noStrike" cap="none" dirty="0">
                          <a:solidFill>
                            <a:srgbClr val="000000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-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 dirty="0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Total</a:t>
                      </a:r>
                      <a:endParaRPr dirty="0"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806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 </a:t>
                      </a:r>
                      <a:endParaRPr/>
                    </a:p>
                  </a:txBody>
                  <a:tcPr marL="5925" marR="5925" marT="5925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806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 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806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 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806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 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806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 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806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 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806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 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806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 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806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 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806000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327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80600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11</a:t>
                      </a:r>
                      <a:endParaRPr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806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 dirty="0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1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806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FFFFFF"/>
                        </a:buClr>
                        <a:buSzPts val="1000"/>
                        <a:buFont typeface="Arial Narrow"/>
                        <a:buNone/>
                      </a:pPr>
                      <a:r>
                        <a:rPr lang="es-ES" sz="1000" b="1" i="0" u="none" strike="noStrike" cap="none" dirty="0">
                          <a:solidFill>
                            <a:srgbClr val="FFFFFF"/>
                          </a:solidFill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 </a:t>
                      </a:r>
                      <a:endParaRPr dirty="0"/>
                    </a:p>
                  </a:txBody>
                  <a:tcPr marL="5925" marR="5925" marT="59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806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</a:tbl>
          </a:graphicData>
        </a:graphic>
      </p:graphicFrame>
      <p:sp>
        <p:nvSpPr>
          <p:cNvPr id="5" name="Google Shape;85;p1">
            <a:extLst>
              <a:ext uri="{FF2B5EF4-FFF2-40B4-BE49-F238E27FC236}">
                <a16:creationId xmlns:a16="http://schemas.microsoft.com/office/drawing/2014/main" id="{83F6E305-56BB-ED75-FC84-05865E758BE4}"/>
              </a:ext>
            </a:extLst>
          </p:cNvPr>
          <p:cNvSpPr txBox="1"/>
          <p:nvPr/>
        </p:nvSpPr>
        <p:spPr>
          <a:xfrm>
            <a:off x="126812" y="9734822"/>
            <a:ext cx="6034200" cy="261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100" b="0" i="0" u="none" strike="noStrike" cap="none" baseline="30000" dirty="0">
                <a:solidFill>
                  <a:schemeClr val="dk1"/>
                </a:solidFill>
                <a:latin typeface="Arial Narrow"/>
                <a:ea typeface="Arial Narrow"/>
                <a:cs typeface="Arial Narrow"/>
                <a:sym typeface="Arial Narrow"/>
              </a:rPr>
              <a:t>h</a:t>
            </a:r>
            <a:r>
              <a:rPr lang="es-ES" sz="1100" b="0" i="0" u="none" strike="noStrike" cap="none" dirty="0">
                <a:solidFill>
                  <a:schemeClr val="dk1"/>
                </a:solidFill>
                <a:latin typeface="Arial Narrow"/>
                <a:ea typeface="Arial Narrow"/>
                <a:cs typeface="Arial Narrow"/>
                <a:sym typeface="Arial Narrow"/>
              </a:rPr>
              <a:t> Gene </a:t>
            </a:r>
            <a:r>
              <a:rPr lang="es-ES" sz="1100" b="0" i="0" u="none" strike="noStrike" cap="none" dirty="0" err="1">
                <a:solidFill>
                  <a:schemeClr val="dk1"/>
                </a:solidFill>
                <a:latin typeface="Arial Narrow"/>
                <a:ea typeface="Arial Narrow"/>
                <a:cs typeface="Arial Narrow"/>
                <a:sym typeface="Arial Narrow"/>
              </a:rPr>
              <a:t>mutations</a:t>
            </a:r>
            <a:r>
              <a:rPr lang="es-ES" sz="1100" b="0" i="0" u="none" strike="noStrike" cap="none" dirty="0">
                <a:solidFill>
                  <a:schemeClr val="dk1"/>
                </a:solidFill>
                <a:latin typeface="Arial Narrow"/>
                <a:ea typeface="Arial Narrow"/>
                <a:cs typeface="Arial Narrow"/>
                <a:sym typeface="Arial Narrow"/>
              </a:rPr>
              <a:t> </a:t>
            </a:r>
            <a:r>
              <a:rPr lang="es-ES" sz="1100" b="0" i="0" u="none" strike="noStrike" cap="none" dirty="0" err="1">
                <a:solidFill>
                  <a:schemeClr val="dk1"/>
                </a:solidFill>
                <a:latin typeface="Arial Narrow"/>
                <a:ea typeface="Arial Narrow"/>
                <a:cs typeface="Arial Narrow"/>
                <a:sym typeface="Arial Narrow"/>
              </a:rPr>
              <a:t>found</a:t>
            </a:r>
            <a:r>
              <a:rPr lang="es-ES" sz="1100" dirty="0">
                <a:solidFill>
                  <a:schemeClr val="dk1"/>
                </a:solidFill>
                <a:latin typeface="Arial Narrow"/>
                <a:ea typeface="Arial Narrow"/>
                <a:cs typeface="Arial Narrow"/>
                <a:sym typeface="Arial Narrow"/>
              </a:rPr>
              <a:t> </a:t>
            </a:r>
            <a:r>
              <a:rPr lang="es-ES" sz="1100" b="0" i="0" u="none" strike="noStrike" cap="none" dirty="0">
                <a:solidFill>
                  <a:schemeClr val="dk1"/>
                </a:solidFill>
                <a:latin typeface="Arial Narrow"/>
                <a:ea typeface="Arial Narrow"/>
                <a:cs typeface="Arial Narrow"/>
                <a:sym typeface="Arial Narrow"/>
              </a:rPr>
              <a:t>in </a:t>
            </a:r>
            <a:r>
              <a:rPr lang="es-ES" sz="1100" b="0" i="0" u="none" strike="noStrike" cap="none" dirty="0" err="1">
                <a:solidFill>
                  <a:schemeClr val="dk1"/>
                </a:solidFill>
                <a:latin typeface="Arial Narrow"/>
                <a:ea typeface="Arial Narrow"/>
                <a:cs typeface="Arial Narrow"/>
                <a:sym typeface="Arial Narrow"/>
              </a:rPr>
              <a:t>heterozygosity</a:t>
            </a:r>
            <a:r>
              <a:rPr lang="es-ES" sz="1100" b="0" i="0" u="none" strike="noStrike" cap="none" dirty="0">
                <a:solidFill>
                  <a:schemeClr val="dk1"/>
                </a:solidFill>
                <a:latin typeface="Arial Narrow"/>
                <a:ea typeface="Arial Narrow"/>
                <a:cs typeface="Arial Narrow"/>
                <a:sym typeface="Arial Narrow"/>
              </a:rPr>
              <a:t> with </a:t>
            </a:r>
            <a:r>
              <a:rPr lang="es-ES" sz="1100" b="0" i="0" u="none" strike="noStrike" cap="none" dirty="0" err="1">
                <a:solidFill>
                  <a:schemeClr val="dk1"/>
                </a:solidFill>
                <a:latin typeface="Arial Narrow"/>
                <a:ea typeface="Arial Narrow"/>
                <a:cs typeface="Arial Narrow"/>
                <a:sym typeface="Arial Narrow"/>
              </a:rPr>
              <a:t>another</a:t>
            </a:r>
            <a:r>
              <a:rPr lang="es-ES" sz="1100" b="0" i="0" u="none" strike="noStrike" cap="none" dirty="0">
                <a:solidFill>
                  <a:schemeClr val="dk1"/>
                </a:solidFill>
                <a:latin typeface="Arial Narrow"/>
                <a:ea typeface="Arial Narrow"/>
                <a:cs typeface="Arial Narrow"/>
                <a:sym typeface="Arial Narrow"/>
              </a:rPr>
              <a:t> gene.</a:t>
            </a:r>
            <a:endParaRPr dirty="0"/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02416C3E-5F48-5B16-94DB-00C1581FF775}"/>
              </a:ext>
            </a:extLst>
          </p:cNvPr>
          <p:cNvSpPr txBox="1"/>
          <p:nvPr/>
        </p:nvSpPr>
        <p:spPr>
          <a:xfrm>
            <a:off x="126812" y="6574926"/>
            <a:ext cx="730605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ble S2. </a:t>
            </a:r>
            <a:r>
              <a:rPr lang="en-US" sz="120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mber of independent clones carrying suppressor mutations in the indicated genes or their cis-regulatory elements (−35 box, −10 box, or Shine–Dalgarno sequence) across bacterial phyla in (p)</a:t>
            </a:r>
            <a:r>
              <a:rPr lang="en-US" sz="1200" kern="1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pGpp</a:t>
            </a:r>
            <a:r>
              <a:rPr lang="en-US" sz="120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⁰ strains.</a:t>
            </a:r>
          </a:p>
        </p:txBody>
      </p:sp>
      <p:graphicFrame>
        <p:nvGraphicFramePr>
          <p:cNvPr id="7" name="Tabla 6">
            <a:extLst>
              <a:ext uri="{FF2B5EF4-FFF2-40B4-BE49-F238E27FC236}">
                <a16:creationId xmlns:a16="http://schemas.microsoft.com/office/drawing/2014/main" id="{0653C5D1-A64D-E98F-E601-74732769CDE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15420674"/>
              </p:ext>
            </p:extLst>
          </p:nvPr>
        </p:nvGraphicFramePr>
        <p:xfrm>
          <a:off x="1257702" y="1454239"/>
          <a:ext cx="4066653" cy="3476625"/>
        </p:xfrm>
        <a:graphic>
          <a:graphicData uri="http://schemas.openxmlformats.org/drawingml/2006/table">
            <a:tbl>
              <a:tblPr firstRow="1" firstCol="1" bandRow="1"/>
              <a:tblGrid>
                <a:gridCol w="753314">
                  <a:extLst>
                    <a:ext uri="{9D8B030D-6E8A-4147-A177-3AD203B41FA5}">
                      <a16:colId xmlns:a16="http://schemas.microsoft.com/office/drawing/2014/main" val="2395729996"/>
                    </a:ext>
                  </a:extLst>
                </a:gridCol>
                <a:gridCol w="172923">
                  <a:extLst>
                    <a:ext uri="{9D8B030D-6E8A-4147-A177-3AD203B41FA5}">
                      <a16:colId xmlns:a16="http://schemas.microsoft.com/office/drawing/2014/main" val="3553935466"/>
                    </a:ext>
                  </a:extLst>
                </a:gridCol>
                <a:gridCol w="3140416">
                  <a:extLst>
                    <a:ext uri="{9D8B030D-6E8A-4147-A177-3AD203B41FA5}">
                      <a16:colId xmlns:a16="http://schemas.microsoft.com/office/drawing/2014/main" val="328858377"/>
                    </a:ext>
                  </a:extLst>
                </a:gridCol>
              </a:tblGrid>
              <a:tr h="35433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buNone/>
                      </a:pPr>
                      <a:r>
                        <a:rPr lang="fr-FR" sz="11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ame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3025" marR="7302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buNone/>
                      </a:pPr>
                      <a:r>
                        <a:rPr lang="fr-FR" sz="11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quence (5'</a:t>
                      </a:r>
                      <a:r>
                        <a:rPr lang="fr-FR" sz="11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fr-FR" sz="11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')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3025" marR="7302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3295935"/>
                  </a:ext>
                </a:extLst>
              </a:tr>
              <a:tr h="283845">
                <a:tc grid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fr-FR" sz="11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lA-2F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3025" marR="7302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CCAGCCAAAAGGG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3025" marR="7302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91775936"/>
                  </a:ext>
                </a:extLst>
              </a:tr>
              <a:tr h="283845">
                <a:tc grid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relA-2R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3025" marR="7302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GCGCAATAAGTGCC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3025" marR="7302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4093113"/>
                  </a:ext>
                </a:extLst>
              </a:tr>
              <a:tr h="283845">
                <a:tc grid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fr-FR" sz="11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l-3F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3025" marR="7302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GATTATTGGTGTTGAAGG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3025" marR="7302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5042286"/>
                  </a:ext>
                </a:extLst>
              </a:tr>
              <a:tr h="283845">
                <a:tc grid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fr-FR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uaB-1F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3025" marR="7302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CTGGCGTCATCGCTGTCTG</a:t>
                      </a:r>
                      <a:endParaRPr lang="es-ES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3025" marR="7302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3196600"/>
                  </a:ext>
                </a:extLst>
              </a:tr>
              <a:tr h="283845">
                <a:tc grid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fr-FR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uaB-1R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3025" marR="7302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AGAACTTTTGGGCCGCAG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3025" marR="7302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0122736"/>
                  </a:ext>
                </a:extLst>
              </a:tr>
              <a:tr h="283845">
                <a:tc grid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fr-FR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uaA-1F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3025" marR="7302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CTTGGCTGACGAACCGA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3025" marR="7302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78181670"/>
                  </a:ext>
                </a:extLst>
              </a:tr>
              <a:tr h="283845">
                <a:tc grid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fr-FR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uaA-1R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3025" marR="7302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GACTGCTCTGCCGTTATC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3025" marR="7302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537231"/>
                  </a:ext>
                </a:extLst>
              </a:tr>
              <a:tr h="283845">
                <a:tc grid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fr-FR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rC-1F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3025" marR="7302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ATCCTTGCCTGTCTCCG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3025" marR="7302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6598736"/>
                  </a:ext>
                </a:extLst>
              </a:tr>
              <a:tr h="283845">
                <a:tc grid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fr-FR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rC-1R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3025" marR="7302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CACGGATGCTCTACGTC</a:t>
                      </a:r>
                      <a:endParaRPr lang="es-ES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3025" marR="7302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03740746"/>
                  </a:ext>
                </a:extLst>
              </a:tr>
              <a:tr h="283845">
                <a:tc grid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fr-FR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psB-1F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3025" marR="7302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TTCGGGTGTTCATTCC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3025" marR="7302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1314064"/>
                  </a:ext>
                </a:extLst>
              </a:tr>
              <a:tr h="283845">
                <a:tc grid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fr-FR" sz="11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psB-1R</a:t>
                      </a:r>
                      <a:endParaRPr lang="es-ES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3025" marR="7302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ATGAGGCGGTGGAG</a:t>
                      </a:r>
                      <a:endParaRPr lang="es-ES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3025" marR="7302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340684"/>
                  </a:ext>
                </a:extLst>
              </a:tr>
            </a:tbl>
          </a:graphicData>
        </a:graphic>
      </p:graphicFrame>
      <p:sp>
        <p:nvSpPr>
          <p:cNvPr id="8" name="Rectangle 2">
            <a:extLst>
              <a:ext uri="{FF2B5EF4-FFF2-40B4-BE49-F238E27FC236}">
                <a16:creationId xmlns:a16="http://schemas.microsoft.com/office/drawing/2014/main" id="{CEBD4DB6-AEF0-7E01-9790-F8B23D0601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6043" y="1165582"/>
            <a:ext cx="2507987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E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able S1. </a:t>
            </a:r>
            <a:r>
              <a:rPr kumimoji="0" lang="en-US" altLang="es-E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Oligonucleotides.</a:t>
            </a:r>
            <a:endParaRPr kumimoji="0" lang="en-US" altLang="es-ES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22511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576</TotalTime>
  <Words>327</Words>
  <Application>Microsoft Office PowerPoint</Application>
  <PresentationFormat>Personalizado</PresentationFormat>
  <Paragraphs>233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ptos</vt:lpstr>
      <vt:lpstr>Arial Narrow</vt:lpstr>
      <vt:lpstr>Times New Roman</vt:lpstr>
      <vt:lpstr>Calibri</vt:lpstr>
      <vt:lpstr>Arial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ose Ignacio LS</dc:creator>
  <cp:lastModifiedBy>antonio llop estevez</cp:lastModifiedBy>
  <cp:revision>354</cp:revision>
  <dcterms:created xsi:type="dcterms:W3CDTF">2021-12-07T11:43:05Z</dcterms:created>
  <dcterms:modified xsi:type="dcterms:W3CDTF">2026-04-20T15:38:40Z</dcterms:modified>
</cp:coreProperties>
</file>